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7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C37FE-92EE-4A07-A958-5CBF0E277A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B3C641-664E-4461-B63B-55245B26E7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D8DAC2-1564-4A2A-A42E-932C61220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BBA466-B43C-4B06-93B8-82768A7DA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867A4-5C4B-490E-9E5C-D3D4D9C98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909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B5D89E-1E34-46E8-917A-B52F4A819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D4DECD-8C4B-4B93-A927-7E2ECD2E81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8ECF39-7B9D-4547-A7AC-7E9081DAA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553C7D-91EE-44D7-8834-99709E421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D403C2-EC34-49FB-959F-24C316DC4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4030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34194B-2372-46EC-86CD-398F9393FB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146501-34BD-4C01-B380-7A64644D5A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5D3AB2-2346-42A8-9750-43A688010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431035-B20E-4828-8D19-C121A2966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FA5D5D-84AD-4D7E-92EE-876BCF7C5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381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B2822-A0BD-4293-B0EA-859BB57AA8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541911-3775-4691-8513-E445A563F1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A5224-9256-4D88-8DD2-9F9EE3390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73B96C-319D-4B8E-9D1F-54D686EB8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3AA3D5-0DEE-4E2F-8974-7FEF9D74B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735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DFD7A-43BA-46BF-8AAD-24B94221B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6C070B-7AE7-41C7-A4B9-C40013BEDD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801D6-032E-40D4-B77F-D62B44D4F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F06DA-5B88-41D4-BC69-B9B139599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1485D3-7895-468E-8F03-D4900093A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348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8E8F36-8337-4867-B9D7-46D91A28A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AAF7A0-911D-477F-914F-86384AE614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C0EFE30-6ACC-4ADE-8C0D-FD6D89C48F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8EC154-070B-48ED-A59A-B950033B1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43A025-B7A0-466C-A7F6-D2096D0FA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C567FF-468D-46DE-ADDE-CD33BDE52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557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3692EB-E92C-4DB9-8BE5-0A5485ACE2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56A847-3DFE-40A9-8DE4-AD5C7A62C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78571C-8F93-4E66-9478-0073A39D2A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9D9DD4-D1AD-4F4B-AAA6-61A216279D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BD1620-5E6C-46F5-9685-41494B9DF3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A3926A-592A-4E43-8C8B-07812D201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8DD3054-51CA-4A8E-AFBD-9E01FB485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1C8C347-FBFB-451F-BD29-2F86757D3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241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E0D53-BC96-49B8-904F-DEC02A4BA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9FBAF2-82B1-4091-8F8C-6C3A5B777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858A45-F14B-4A36-A3A1-53A171BEC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BF6AD2-0947-4671-ACB9-E1A52138B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638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44AE39-EE09-4490-A371-52F8ADA03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52F9F9-008B-4EAF-876E-2C07404895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4C6A8F-BC4E-4A71-BC3A-367DA29D0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431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949FF-AEC2-4C51-A28F-EE2D20AD4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875716-582F-4B04-AB38-57A0E83AA7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9BDDE2-8757-4898-B8BB-24472752CF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4CCCDF-3689-4C0B-BA3B-A1A1693AB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EB327B-8589-41F0-ABCE-DE22A1F84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5E7547-9BF0-4EDA-8382-F303FFA12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430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9D4C8-FD67-43EA-A1D9-FB5B2EBC1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7399E5-CBBC-413B-8647-A7BE643C33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DF982C-B2CC-4054-AF60-DC1D45AACA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C1CFEC-7C83-4063-BAC5-741ADFDE2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FC6240-E08B-43FC-B18B-076C841AB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955CE5-7595-4C50-91EB-6DB654E6F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823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CBADC3-18C5-4129-A052-035929D9B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924753-8472-48A2-836D-6871AD6BD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B6FD11-88E7-484D-A9E5-CC8612412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5D8331-3C2B-4C6D-BA72-831CE6107491}" type="datetimeFigureOut">
              <a:rPr lang="en-US" smtClean="0"/>
              <a:t>9/1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B9E8E5-4C48-4A9B-A182-0D3868F789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362F1A-D955-4A0E-B0C8-AB2E80781A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AC2C6-3FDB-425D-BAAD-AB24A65002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039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82">
            <a:extLst>
              <a:ext uri="{FF2B5EF4-FFF2-40B4-BE49-F238E27FC236}">
                <a16:creationId xmlns:a16="http://schemas.microsoft.com/office/drawing/2014/main" id="{B77AEC96-2053-4630-91D8-6C2789F3775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5" t="7819" r="27162" b="58706"/>
          <a:stretch/>
        </p:blipFill>
        <p:spPr>
          <a:xfrm>
            <a:off x="5947309" y="1098389"/>
            <a:ext cx="1428772" cy="1372584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7B25613F-745A-46EE-A465-2A40B525A47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07" t="6759" r="30780" b="61706"/>
          <a:stretch/>
        </p:blipFill>
        <p:spPr>
          <a:xfrm>
            <a:off x="1057169" y="1146278"/>
            <a:ext cx="1386997" cy="1293048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id="{83C77DCF-BCDD-46A3-8B70-ED0B7E19FB0C}"/>
              </a:ext>
            </a:extLst>
          </p:cNvPr>
          <p:cNvSpPr txBox="1"/>
          <p:nvPr/>
        </p:nvSpPr>
        <p:spPr>
          <a:xfrm flipH="1">
            <a:off x="306711" y="119695"/>
            <a:ext cx="62615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Figure7 – panel N</a:t>
            </a:r>
          </a:p>
        </p:txBody>
      </p:sp>
      <p:sp>
        <p:nvSpPr>
          <p:cNvPr id="115" name="ZoneTexte 8">
            <a:extLst>
              <a:ext uri="{FF2B5EF4-FFF2-40B4-BE49-F238E27FC236}">
                <a16:creationId xmlns:a16="http://schemas.microsoft.com/office/drawing/2014/main" id="{9225CC9C-2F5A-42DE-B1EC-6B9527B984B9}"/>
              </a:ext>
            </a:extLst>
          </p:cNvPr>
          <p:cNvSpPr txBox="1"/>
          <p:nvPr/>
        </p:nvSpPr>
        <p:spPr>
          <a:xfrm>
            <a:off x="5619315" y="183920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55 kDa</a:t>
            </a:r>
          </a:p>
        </p:txBody>
      </p:sp>
      <p:sp>
        <p:nvSpPr>
          <p:cNvPr id="116" name="ZoneTexte 11">
            <a:extLst>
              <a:ext uri="{FF2B5EF4-FFF2-40B4-BE49-F238E27FC236}">
                <a16:creationId xmlns:a16="http://schemas.microsoft.com/office/drawing/2014/main" id="{318DE597-FD8D-48B2-9E30-A59A1ECAF7F4}"/>
              </a:ext>
            </a:extLst>
          </p:cNvPr>
          <p:cNvSpPr txBox="1"/>
          <p:nvPr/>
        </p:nvSpPr>
        <p:spPr>
          <a:xfrm>
            <a:off x="5619315" y="147026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117" name="ZoneTexte 15">
            <a:extLst>
              <a:ext uri="{FF2B5EF4-FFF2-40B4-BE49-F238E27FC236}">
                <a16:creationId xmlns:a16="http://schemas.microsoft.com/office/drawing/2014/main" id="{7CD29631-0F44-45C9-80F5-1D0976874272}"/>
              </a:ext>
            </a:extLst>
          </p:cNvPr>
          <p:cNvSpPr txBox="1"/>
          <p:nvPr/>
        </p:nvSpPr>
        <p:spPr>
          <a:xfrm>
            <a:off x="5654581" y="165213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70kDa</a:t>
            </a:r>
          </a:p>
        </p:txBody>
      </p:sp>
      <p:sp>
        <p:nvSpPr>
          <p:cNvPr id="118" name="ZoneTexte 8">
            <a:extLst>
              <a:ext uri="{FF2B5EF4-FFF2-40B4-BE49-F238E27FC236}">
                <a16:creationId xmlns:a16="http://schemas.microsoft.com/office/drawing/2014/main" id="{09866E71-84B1-4147-AC21-694208EADCAE}"/>
              </a:ext>
            </a:extLst>
          </p:cNvPr>
          <p:cNvSpPr txBox="1"/>
          <p:nvPr/>
        </p:nvSpPr>
        <p:spPr>
          <a:xfrm>
            <a:off x="5606901" y="116935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119" name="ZoneTexte 9">
            <a:extLst>
              <a:ext uri="{FF2B5EF4-FFF2-40B4-BE49-F238E27FC236}">
                <a16:creationId xmlns:a16="http://schemas.microsoft.com/office/drawing/2014/main" id="{C84300CA-8800-450A-B2EB-47B5529CE939}"/>
              </a:ext>
            </a:extLst>
          </p:cNvPr>
          <p:cNvSpPr txBox="1"/>
          <p:nvPr/>
        </p:nvSpPr>
        <p:spPr>
          <a:xfrm>
            <a:off x="5596985" y="131685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9F462F0B-1C97-4F94-A2F2-6402224017B2}"/>
              </a:ext>
            </a:extLst>
          </p:cNvPr>
          <p:cNvSpPr txBox="1"/>
          <p:nvPr/>
        </p:nvSpPr>
        <p:spPr>
          <a:xfrm rot="16200000">
            <a:off x="6704812" y="128331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T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93F68641-C327-4B05-BC5C-C482B23D3C2B}"/>
              </a:ext>
            </a:extLst>
          </p:cNvPr>
          <p:cNvSpPr txBox="1"/>
          <p:nvPr/>
        </p:nvSpPr>
        <p:spPr>
          <a:xfrm rot="16200000">
            <a:off x="6345679" y="1275052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HOM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BE4F06CB-DF0B-48F3-9742-FC67E6303232}"/>
              </a:ext>
            </a:extLst>
          </p:cNvPr>
          <p:cNvSpPr txBox="1"/>
          <p:nvPr/>
        </p:nvSpPr>
        <p:spPr>
          <a:xfrm rot="16200000">
            <a:off x="1676425" y="142668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T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674DE090-F92F-4971-BEBD-38E09A62A261}"/>
              </a:ext>
            </a:extLst>
          </p:cNvPr>
          <p:cNvSpPr txBox="1"/>
          <p:nvPr/>
        </p:nvSpPr>
        <p:spPr>
          <a:xfrm rot="16200000">
            <a:off x="1317292" y="1418416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HOM</a:t>
            </a:r>
          </a:p>
        </p:txBody>
      </p:sp>
      <p:sp>
        <p:nvSpPr>
          <p:cNvPr id="140" name="ZoneTexte 8">
            <a:extLst>
              <a:ext uri="{FF2B5EF4-FFF2-40B4-BE49-F238E27FC236}">
                <a16:creationId xmlns:a16="http://schemas.microsoft.com/office/drawing/2014/main" id="{6D2A2DD9-2B46-4C42-B097-9C51BC85B0D0}"/>
              </a:ext>
            </a:extLst>
          </p:cNvPr>
          <p:cNvSpPr txBox="1"/>
          <p:nvPr/>
        </p:nvSpPr>
        <p:spPr>
          <a:xfrm>
            <a:off x="667969" y="128205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141" name="ZoneTexte 9">
            <a:extLst>
              <a:ext uri="{FF2B5EF4-FFF2-40B4-BE49-F238E27FC236}">
                <a16:creationId xmlns:a16="http://schemas.microsoft.com/office/drawing/2014/main" id="{39F13981-33C4-493C-B56D-42CFE125CABC}"/>
              </a:ext>
            </a:extLst>
          </p:cNvPr>
          <p:cNvSpPr txBox="1"/>
          <p:nvPr/>
        </p:nvSpPr>
        <p:spPr>
          <a:xfrm>
            <a:off x="674129" y="142529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142" name="ZoneTexte 11">
            <a:extLst>
              <a:ext uri="{FF2B5EF4-FFF2-40B4-BE49-F238E27FC236}">
                <a16:creationId xmlns:a16="http://schemas.microsoft.com/office/drawing/2014/main" id="{433400BC-1E46-4525-A3FE-9F9C42092E98}"/>
              </a:ext>
            </a:extLst>
          </p:cNvPr>
          <p:cNvSpPr txBox="1"/>
          <p:nvPr/>
        </p:nvSpPr>
        <p:spPr>
          <a:xfrm>
            <a:off x="639402" y="158354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143" name="ZoneTexte 15">
            <a:extLst>
              <a:ext uri="{FF2B5EF4-FFF2-40B4-BE49-F238E27FC236}">
                <a16:creationId xmlns:a16="http://schemas.microsoft.com/office/drawing/2014/main" id="{EA960955-99EA-4195-84EE-8638B2767F77}"/>
              </a:ext>
            </a:extLst>
          </p:cNvPr>
          <p:cNvSpPr txBox="1"/>
          <p:nvPr/>
        </p:nvSpPr>
        <p:spPr>
          <a:xfrm>
            <a:off x="717949" y="1729637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70kDa</a:t>
            </a:r>
          </a:p>
        </p:txBody>
      </p:sp>
      <p:sp>
        <p:nvSpPr>
          <p:cNvPr id="144" name="ZoneTexte 8">
            <a:extLst>
              <a:ext uri="{FF2B5EF4-FFF2-40B4-BE49-F238E27FC236}">
                <a16:creationId xmlns:a16="http://schemas.microsoft.com/office/drawing/2014/main" id="{F2B98530-DACF-4C97-AC2A-268B5CBA5E7E}"/>
              </a:ext>
            </a:extLst>
          </p:cNvPr>
          <p:cNvSpPr txBox="1"/>
          <p:nvPr/>
        </p:nvSpPr>
        <p:spPr>
          <a:xfrm>
            <a:off x="692323" y="194292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55 kDa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9663CF6D-B17B-4E48-B671-1957857BA3B3}"/>
              </a:ext>
            </a:extLst>
          </p:cNvPr>
          <p:cNvSpPr txBox="1"/>
          <p:nvPr/>
        </p:nvSpPr>
        <p:spPr>
          <a:xfrm>
            <a:off x="2369933" y="1887371"/>
            <a:ext cx="2413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pha tub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B90E2BAD-6636-4E93-B29E-AFE51FDA0DCE}"/>
              </a:ext>
            </a:extLst>
          </p:cNvPr>
          <p:cNvSpPr/>
          <p:nvPr/>
        </p:nvSpPr>
        <p:spPr>
          <a:xfrm>
            <a:off x="1380954" y="2000875"/>
            <a:ext cx="728597" cy="2422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A9344223-6D20-4AD4-87C3-9857D0DEEEF0}"/>
              </a:ext>
            </a:extLst>
          </p:cNvPr>
          <p:cNvSpPr/>
          <p:nvPr/>
        </p:nvSpPr>
        <p:spPr>
          <a:xfrm>
            <a:off x="6442627" y="1911758"/>
            <a:ext cx="728597" cy="2422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3736409D-35AC-479A-9B5B-382FC5252530}"/>
              </a:ext>
            </a:extLst>
          </p:cNvPr>
          <p:cNvSpPr txBox="1"/>
          <p:nvPr/>
        </p:nvSpPr>
        <p:spPr>
          <a:xfrm>
            <a:off x="3437487" y="5907308"/>
            <a:ext cx="64320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Images were rotated while preparing the figure to start with the WT sample</a:t>
            </a:r>
          </a:p>
          <a:p>
            <a:endParaRPr lang="en-US" sz="1600" dirty="0"/>
          </a:p>
          <a:p>
            <a:r>
              <a:rPr lang="en-US" sz="1600" dirty="0"/>
              <a:t>Rectangle shows the cropped area used in the figure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D1AF3B99-BD2E-4523-A981-857B8B2465C8}"/>
              </a:ext>
            </a:extLst>
          </p:cNvPr>
          <p:cNvSpPr/>
          <p:nvPr/>
        </p:nvSpPr>
        <p:spPr>
          <a:xfrm>
            <a:off x="5869641" y="2869494"/>
            <a:ext cx="2073207" cy="27931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479C6DA6-08C9-4E07-8691-2D47E135518E}"/>
              </a:ext>
            </a:extLst>
          </p:cNvPr>
          <p:cNvSpPr/>
          <p:nvPr/>
        </p:nvSpPr>
        <p:spPr>
          <a:xfrm>
            <a:off x="895463" y="2822855"/>
            <a:ext cx="2203997" cy="27931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0" name="Picture 79">
            <a:extLst>
              <a:ext uri="{FF2B5EF4-FFF2-40B4-BE49-F238E27FC236}">
                <a16:creationId xmlns:a16="http://schemas.microsoft.com/office/drawing/2014/main" id="{F3E612F1-14E0-4012-B875-5DE489288F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3000" y="2890738"/>
            <a:ext cx="1995055" cy="274320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2E7CB7B8-EB8A-4FD9-9167-2D3965BED11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3495" y="2872826"/>
            <a:ext cx="1995055" cy="2743200"/>
          </a:xfrm>
          <a:prstGeom prst="rect">
            <a:avLst/>
          </a:prstGeom>
        </p:spPr>
      </p:pic>
      <p:sp>
        <p:nvSpPr>
          <p:cNvPr id="151" name="Rectangle 150">
            <a:extLst>
              <a:ext uri="{FF2B5EF4-FFF2-40B4-BE49-F238E27FC236}">
                <a16:creationId xmlns:a16="http://schemas.microsoft.com/office/drawing/2014/main" id="{2367AFDD-8A2E-4642-90B4-B80359743B99}"/>
              </a:ext>
            </a:extLst>
          </p:cNvPr>
          <p:cNvSpPr/>
          <p:nvPr/>
        </p:nvSpPr>
        <p:spPr>
          <a:xfrm>
            <a:off x="1533354" y="3590192"/>
            <a:ext cx="728597" cy="2422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" name="Rectangle 151">
            <a:extLst>
              <a:ext uri="{FF2B5EF4-FFF2-40B4-BE49-F238E27FC236}">
                <a16:creationId xmlns:a16="http://schemas.microsoft.com/office/drawing/2014/main" id="{4990EC15-F0B9-4BC7-85DB-B3D362C43071}"/>
              </a:ext>
            </a:extLst>
          </p:cNvPr>
          <p:cNvSpPr/>
          <p:nvPr/>
        </p:nvSpPr>
        <p:spPr>
          <a:xfrm>
            <a:off x="6568484" y="3613940"/>
            <a:ext cx="728597" cy="2422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10755CA1-8133-4FDC-A180-0F33A22D1708}"/>
              </a:ext>
            </a:extLst>
          </p:cNvPr>
          <p:cNvSpPr txBox="1"/>
          <p:nvPr/>
        </p:nvSpPr>
        <p:spPr>
          <a:xfrm rot="16200000">
            <a:off x="1813541" y="3191495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T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153891E-0547-41BF-9F80-0BED4AC1B6DA}"/>
              </a:ext>
            </a:extLst>
          </p:cNvPr>
          <p:cNvSpPr txBox="1"/>
          <p:nvPr/>
        </p:nvSpPr>
        <p:spPr>
          <a:xfrm rot="16200000">
            <a:off x="1454408" y="3183231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HOM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5BD5AD8C-BBE6-490A-8A52-02D0BF258C0A}"/>
              </a:ext>
            </a:extLst>
          </p:cNvPr>
          <p:cNvSpPr txBox="1"/>
          <p:nvPr/>
        </p:nvSpPr>
        <p:spPr>
          <a:xfrm rot="16200000">
            <a:off x="6858700" y="3253206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WT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E938704A-0F1E-4B0F-891E-0DBB00018FF8}"/>
              </a:ext>
            </a:extLst>
          </p:cNvPr>
          <p:cNvSpPr txBox="1"/>
          <p:nvPr/>
        </p:nvSpPr>
        <p:spPr>
          <a:xfrm rot="16200000">
            <a:off x="6499567" y="3244942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HOM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A1BA112F-6068-4A7C-A06E-620C5BAB8C06}"/>
              </a:ext>
            </a:extLst>
          </p:cNvPr>
          <p:cNvSpPr txBox="1"/>
          <p:nvPr/>
        </p:nvSpPr>
        <p:spPr>
          <a:xfrm flipH="1">
            <a:off x="7635730" y="2009398"/>
            <a:ext cx="2548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etylated-alpha-tub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336EFB97-FDCF-4C2C-A267-365BC6E10C9E}"/>
              </a:ext>
            </a:extLst>
          </p:cNvPr>
          <p:cNvSpPr txBox="1"/>
          <p:nvPr/>
        </p:nvSpPr>
        <p:spPr>
          <a:xfrm>
            <a:off x="2295562" y="3526638"/>
            <a:ext cx="2413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lpha tub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916F28B6-A532-4727-B996-20ED3FDC5ABB}"/>
              </a:ext>
            </a:extLst>
          </p:cNvPr>
          <p:cNvSpPr txBox="1"/>
          <p:nvPr/>
        </p:nvSpPr>
        <p:spPr>
          <a:xfrm flipH="1">
            <a:off x="7289226" y="3564773"/>
            <a:ext cx="2548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cetylated-alpha-tub</a:t>
            </a:r>
          </a:p>
        </p:txBody>
      </p:sp>
      <p:sp>
        <p:nvSpPr>
          <p:cNvPr id="159" name="ZoneTexte 8">
            <a:extLst>
              <a:ext uri="{FF2B5EF4-FFF2-40B4-BE49-F238E27FC236}">
                <a16:creationId xmlns:a16="http://schemas.microsoft.com/office/drawing/2014/main" id="{F8D73FBD-E0AD-4FDD-8D83-598D3FBFEA72}"/>
              </a:ext>
            </a:extLst>
          </p:cNvPr>
          <p:cNvSpPr txBox="1"/>
          <p:nvPr/>
        </p:nvSpPr>
        <p:spPr>
          <a:xfrm>
            <a:off x="5917612" y="357029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55 kDa</a:t>
            </a:r>
          </a:p>
        </p:txBody>
      </p:sp>
      <p:sp>
        <p:nvSpPr>
          <p:cNvPr id="160" name="ZoneTexte 8">
            <a:extLst>
              <a:ext uri="{FF2B5EF4-FFF2-40B4-BE49-F238E27FC236}">
                <a16:creationId xmlns:a16="http://schemas.microsoft.com/office/drawing/2014/main" id="{667B38AA-046D-4B7F-A708-8DFE0B2B41E0}"/>
              </a:ext>
            </a:extLst>
          </p:cNvPr>
          <p:cNvSpPr txBox="1"/>
          <p:nvPr/>
        </p:nvSpPr>
        <p:spPr>
          <a:xfrm>
            <a:off x="933495" y="357916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55 kDa</a:t>
            </a:r>
          </a:p>
        </p:txBody>
      </p:sp>
    </p:spTree>
    <p:extLst>
      <p:ext uri="{BB962C8B-B14F-4D97-AF65-F5344CB8AC3E}">
        <p14:creationId xmlns:p14="http://schemas.microsoft.com/office/powerpoint/2010/main" val="2605857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62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fil BAYAM</dc:creator>
  <cp:lastModifiedBy>Efil BAYAM</cp:lastModifiedBy>
  <cp:revision>3</cp:revision>
  <dcterms:created xsi:type="dcterms:W3CDTF">2024-06-04T09:18:16Z</dcterms:created>
  <dcterms:modified xsi:type="dcterms:W3CDTF">2024-09-14T10:07:57Z</dcterms:modified>
</cp:coreProperties>
</file>